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4"/>
    <p:restoredTop sz="94663"/>
  </p:normalViewPr>
  <p:slideViewPr>
    <p:cSldViewPr snapToGrid="0" snapToObjects="1">
      <p:cViewPr>
        <p:scale>
          <a:sx n="130" d="100"/>
          <a:sy n="130" d="100"/>
        </p:scale>
        <p:origin x="184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465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2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9210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701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67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1419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4283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183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34185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6463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4110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C9ECE9-1BD7-B64B-9BB0-79E5D67C8658}" type="datetimeFigureOut">
              <a:rPr kumimoji="1" lang="ja-JP" altLang="en-US" smtClean="0"/>
              <a:t>2021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93D07E-DAE2-8542-BA5E-3D6996CF30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5197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5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microsoft.com/office/2007/relationships/hdphoto" Target="../media/hdphoto2.wdp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microsoft.com/office/2007/relationships/hdphoto" Target="../media/hdphoto1.wdp"/><Relationship Id="rId10" Type="http://schemas.openxmlformats.org/officeDocument/2006/relationships/image" Target="../media/image9.png"/><Relationship Id="rId19" Type="http://schemas.openxmlformats.org/officeDocument/2006/relationships/image" Target="../media/image16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1DBF2EB-53B2-CB4A-8D9B-8D970DF8F744}"/>
              </a:ext>
            </a:extLst>
          </p:cNvPr>
          <p:cNvSpPr txBox="1"/>
          <p:nvPr/>
        </p:nvSpPr>
        <p:spPr>
          <a:xfrm>
            <a:off x="161366" y="174338"/>
            <a:ext cx="2366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A0F31F8-F6F3-7B40-81C0-00BB1DDB0853}"/>
              </a:ext>
            </a:extLst>
          </p:cNvPr>
          <p:cNvSpPr txBox="1"/>
          <p:nvPr/>
        </p:nvSpPr>
        <p:spPr>
          <a:xfrm>
            <a:off x="341673" y="1987215"/>
            <a:ext cx="1030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2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0C5CCAA-CE2F-8749-B11D-98D175A2295E}"/>
              </a:ext>
            </a:extLst>
          </p:cNvPr>
          <p:cNvSpPr txBox="1"/>
          <p:nvPr/>
        </p:nvSpPr>
        <p:spPr>
          <a:xfrm>
            <a:off x="341673" y="3782150"/>
            <a:ext cx="1030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3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B42718E-BC3E-9B40-AC42-473C2BD7ED44}"/>
              </a:ext>
            </a:extLst>
          </p:cNvPr>
          <p:cNvSpPr txBox="1"/>
          <p:nvPr/>
        </p:nvSpPr>
        <p:spPr>
          <a:xfrm>
            <a:off x="341673" y="5634952"/>
            <a:ext cx="1030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4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715642C-DD2A-B948-8B5B-7881B6F396EC}"/>
              </a:ext>
            </a:extLst>
          </p:cNvPr>
          <p:cNvSpPr txBox="1"/>
          <p:nvPr/>
        </p:nvSpPr>
        <p:spPr>
          <a:xfrm>
            <a:off x="341673" y="7501397"/>
            <a:ext cx="1030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5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FAD537C6-0A42-5044-944A-A65FD315B4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695" t="32172" r="36435" b="32766"/>
          <a:stretch/>
        </p:blipFill>
        <p:spPr>
          <a:xfrm>
            <a:off x="1636789" y="1299948"/>
            <a:ext cx="1154526" cy="1662189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45FD40F9-0B31-9844-9C56-28ACC39D909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192" t="39300" r="44748" b="35447"/>
          <a:stretch/>
        </p:blipFill>
        <p:spPr>
          <a:xfrm>
            <a:off x="2791315" y="1299948"/>
            <a:ext cx="1068883" cy="1662189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45310AAE-B770-BB47-A0BF-6CD653AE83A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6815" t="34332" r="38591" b="32355"/>
          <a:stretch/>
        </p:blipFill>
        <p:spPr>
          <a:xfrm>
            <a:off x="4125276" y="1299948"/>
            <a:ext cx="1154218" cy="1662189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D8AE7C68-986F-0646-9346-A2557921D50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2159" t="35502" r="39941" b="38794"/>
          <a:stretch/>
        </p:blipFill>
        <p:spPr>
          <a:xfrm>
            <a:off x="5279494" y="1299948"/>
            <a:ext cx="1098801" cy="1662189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3BF6BFD5-0F5C-2647-AC71-73244619A13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142" t="31355" r="38608" b="38867"/>
          <a:stretch/>
        </p:blipFill>
        <p:spPr>
          <a:xfrm>
            <a:off x="2791315" y="3151623"/>
            <a:ext cx="1063230" cy="1662189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20B8BE1D-136E-4940-8317-C1ED044589B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4455" t="40356" r="40442" b="25528"/>
          <a:stretch/>
        </p:blipFill>
        <p:spPr>
          <a:xfrm>
            <a:off x="1636789" y="3151623"/>
            <a:ext cx="1155355" cy="166219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7ED65BD4-9207-E44B-A1DA-0E4A18A06DF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8958" t="30981" r="35303" b="35155"/>
          <a:stretch/>
        </p:blipFill>
        <p:spPr>
          <a:xfrm>
            <a:off x="4122663" y="3151623"/>
            <a:ext cx="1188314" cy="1662189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8CFD3A17-1061-A94F-939C-389C4626812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7641" t="31600" r="40505" b="37303"/>
          <a:stretch/>
        </p:blipFill>
        <p:spPr>
          <a:xfrm>
            <a:off x="5279494" y="3151623"/>
            <a:ext cx="1098801" cy="1662189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62110867-4591-2842-B76F-DEE48B90ED86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37706" t="33924" r="38208" b="34548"/>
          <a:stretch/>
        </p:blipFill>
        <p:spPr>
          <a:xfrm>
            <a:off x="1636790" y="5003298"/>
            <a:ext cx="1202036" cy="1662189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A9515EB9-38B4-F749-9023-94C916A766C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40930" t="40021" r="41747" b="33295"/>
          <a:stretch/>
        </p:blipFill>
        <p:spPr>
          <a:xfrm>
            <a:off x="2838826" y="5003296"/>
            <a:ext cx="1015719" cy="1662191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D5DB9B79-908A-6344-BC00-72BE5F03C75A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38061" t="34629" r="38408" b="34629"/>
          <a:stretch/>
        </p:blipFill>
        <p:spPr>
          <a:xfrm>
            <a:off x="4122663" y="5003296"/>
            <a:ext cx="1202036" cy="1662189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26162E55-A2FA-4546-902D-80F5266C2457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41295" t="38942" r="39884" b="33121"/>
          <a:stretch/>
        </p:blipFill>
        <p:spPr>
          <a:xfrm>
            <a:off x="5324154" y="5003296"/>
            <a:ext cx="1054142" cy="1662189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024F35CB-3FE7-C14E-9D06-5DB845E6AA8A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39298" t="5545" r="12877" b="32895"/>
          <a:stretch/>
        </p:blipFill>
        <p:spPr>
          <a:xfrm>
            <a:off x="1636789" y="6854971"/>
            <a:ext cx="1215599" cy="1662189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C03E7539-2A64-6B48-8751-F4A61F8F7DFB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43864" t="44445" r="40006" b="31202"/>
          <a:stretch/>
        </p:blipFill>
        <p:spPr>
          <a:xfrm>
            <a:off x="2821243" y="6854969"/>
            <a:ext cx="1042302" cy="1662189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0A6F1077-F7FB-044E-8FF2-3AF2E7A7CBA2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35703" t="34158" r="39484" b="33390"/>
          <a:stretch/>
        </p:blipFill>
        <p:spPr>
          <a:xfrm>
            <a:off x="4122663" y="6854969"/>
            <a:ext cx="1196396" cy="1662189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93ACBD9E-FB7E-6A47-A0FF-9585F7BBDE96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42176" t="36172" r="40538" b="38442"/>
          <a:stretch/>
        </p:blipFill>
        <p:spPr>
          <a:xfrm>
            <a:off x="5319059" y="6854969"/>
            <a:ext cx="1070458" cy="1662189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1B254FC-E366-9D42-9A8E-8390DAE1D261}"/>
              </a:ext>
            </a:extLst>
          </p:cNvPr>
          <p:cNvSpPr txBox="1"/>
          <p:nvPr/>
        </p:nvSpPr>
        <p:spPr>
          <a:xfrm>
            <a:off x="1594161" y="783257"/>
            <a:ext cx="22804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operative radiographs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70CDC9E-57DC-C140-AC83-ADC512E9A92A}"/>
              </a:ext>
            </a:extLst>
          </p:cNvPr>
          <p:cNvSpPr txBox="1"/>
          <p:nvPr/>
        </p:nvSpPr>
        <p:spPr>
          <a:xfrm>
            <a:off x="4250409" y="657088"/>
            <a:ext cx="191441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ographs</a:t>
            </a:r>
          </a:p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final follow-up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3152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17</Words>
  <Application>Microsoft Macintosh PowerPoint</Application>
  <PresentationFormat>画面に合わせる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tient 2</dc:title>
  <dc:creator>Microsoft Office ユーザー</dc:creator>
  <cp:lastModifiedBy>Microsoft Office ユーザー</cp:lastModifiedBy>
  <cp:revision>7</cp:revision>
  <dcterms:created xsi:type="dcterms:W3CDTF">2021-10-15T11:08:56Z</dcterms:created>
  <dcterms:modified xsi:type="dcterms:W3CDTF">2021-10-23T01:46:44Z</dcterms:modified>
</cp:coreProperties>
</file>